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ED649-56CE-4D09-9ACA-6A01BE0BAD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EDD2B-AE90-4D23-B853-05EC8F1E07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4A0BB-53B4-4701-BE7F-AC9E636EA0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2CCC4-1F65-4015-A8D5-7D0359FF99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E91B2-5E96-472C-9FB7-BC3ED5847F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51274-418B-4771-980C-B9C4E76317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5DED3-67FE-4300-B5B9-BB17D6EC5B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03031-3859-443C-AAF3-921BE7C1D7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C6B95-7422-4692-BE74-1325D3FE53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A7BFB-8A0A-4B9E-B982-2C233DE162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90F2A-85FF-41D1-879A-70A2F58C56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8AF70-8E64-4298-B87F-1F7906B0A4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1F6EE3-ED32-47CB-8808-F2A27B648914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4"/>
          <p:cNvSpPr/>
          <p:nvPr/>
        </p:nvSpPr>
        <p:spPr>
          <a:xfrm>
            <a:off x="1625760" y="1217520"/>
            <a:ext cx="2612880" cy="835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proval by my hospital’s  trauma team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" name="矩形 5"/>
          <p:cNvSpPr/>
          <p:nvPr/>
        </p:nvSpPr>
        <p:spPr>
          <a:xfrm>
            <a:off x="1625760" y="2470320"/>
            <a:ext cx="2612880" cy="8334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cess to evidenc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" name="矩形 6"/>
          <p:cNvSpPr/>
          <p:nvPr/>
        </p:nvSpPr>
        <p:spPr>
          <a:xfrm>
            <a:off x="1625760" y="3747960"/>
            <a:ext cx="2612880" cy="8334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me constraint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" name="矩形 7"/>
          <p:cNvSpPr/>
          <p:nvPr/>
        </p:nvSpPr>
        <p:spPr>
          <a:xfrm>
            <a:off x="1625760" y="5014800"/>
            <a:ext cx="2612880" cy="1016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proval by people less comfortable with information technolog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5" name="矩形 8"/>
          <p:cNvSpPr/>
          <p:nvPr/>
        </p:nvSpPr>
        <p:spPr>
          <a:xfrm>
            <a:off x="7716960" y="2922480"/>
            <a:ext cx="2419200" cy="12430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n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cxnSp>
        <p:nvCxnSpPr>
          <p:cNvPr id="46" name="直接箭头连接符 9"/>
          <p:cNvCxnSpPr>
            <a:stCxn id="41" idx="3"/>
          </p:cNvCxnSpPr>
          <p:nvPr/>
        </p:nvCxnSpPr>
        <p:spPr>
          <a:xfrm>
            <a:off x="4238640" y="1635120"/>
            <a:ext cx="3456720" cy="16423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" name="直接箭头连接符 12"/>
          <p:cNvCxnSpPr/>
          <p:nvPr/>
        </p:nvCxnSpPr>
        <p:spPr>
          <a:xfrm>
            <a:off x="4224240" y="2885760"/>
            <a:ext cx="3471120" cy="5878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8" name="直接箭头连接符 16"/>
          <p:cNvCxnSpPr>
            <a:stCxn id="43" idx="3"/>
          </p:cNvCxnSpPr>
          <p:nvPr/>
        </p:nvCxnSpPr>
        <p:spPr>
          <a:xfrm flipV="1">
            <a:off x="4238640" y="3712320"/>
            <a:ext cx="3456720" cy="4525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9" name="直接箭头连接符 20"/>
          <p:cNvCxnSpPr>
            <a:stCxn id="44" idx="3"/>
          </p:cNvCxnSpPr>
          <p:nvPr/>
        </p:nvCxnSpPr>
        <p:spPr>
          <a:xfrm flipV="1">
            <a:off x="4238640" y="3912480"/>
            <a:ext cx="3479040" cy="16106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0" name="文本框 23"/>
          <p:cNvSpPr/>
          <p:nvPr/>
        </p:nvSpPr>
        <p:spPr>
          <a:xfrm rot="1592400">
            <a:off x="4715640" y="1832040"/>
            <a:ext cx="179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32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&lt; .0001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1" name="文本框 24"/>
          <p:cNvSpPr/>
          <p:nvPr/>
        </p:nvSpPr>
        <p:spPr>
          <a:xfrm rot="531000">
            <a:off x="4352760" y="2724120"/>
            <a:ext cx="19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29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 &lt; .0001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2" name="文本框 25"/>
          <p:cNvSpPr/>
          <p:nvPr/>
        </p:nvSpPr>
        <p:spPr>
          <a:xfrm rot="21064800">
            <a:off x="4568400" y="3627000"/>
            <a:ext cx="208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14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&lt; .0001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3" name="文本框 26"/>
          <p:cNvSpPr/>
          <p:nvPr/>
        </p:nvSpPr>
        <p:spPr>
          <a:xfrm rot="20321400">
            <a:off x="4528800" y="4460760"/>
            <a:ext cx="184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10 ( P= .01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4" name="TextBox 1"/>
          <p:cNvSpPr/>
          <p:nvPr/>
        </p:nvSpPr>
        <p:spPr>
          <a:xfrm>
            <a:off x="2354400" y="260280"/>
            <a:ext cx="6884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ute care health professionals’salient beliefs’analysis</a:t>
            </a:r>
            <a:endParaRPr b="0" lang="en-US" sz="2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6T02:02:54Z</dcterms:created>
  <dc:creator>Lenovo</dc:creator>
  <dc:description/>
  <dc:language>en-US</dc:language>
  <cp:lastModifiedBy>Said Abasse Kassim</cp:lastModifiedBy>
  <dcterms:modified xsi:type="dcterms:W3CDTF">2021-05-24T14:31:25Z</dcterms:modified>
  <cp:revision>44</cp:revision>
  <dc:subject/>
  <dc:title>PowerPoint 演示文稿</dc:title>
</cp:coreProperties>
</file>